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2.png" ContentType="image/png"/>
  <Override PartName="/ppt/media/image20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7.jpeg" ContentType="image/jpeg"/>
  <Override PartName="/ppt/media/image11.jpeg" ContentType="image/jpeg"/>
  <Override PartName="/ppt/media/image9.jpeg" ContentType="image/jpeg"/>
  <Override PartName="/ppt/media/image21.png" ContentType="image/png"/>
  <Override PartName="/ppt/media/image19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81D57-8D25-4CD2-81BE-4F23864887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61FEF-048A-4BC9-AC0E-06281B50D4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73878-01B0-4904-8EA5-37AC0B9BAE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6CA09-4FFF-446F-A3CA-1724EE5D12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DC548-A1E7-4572-8497-6D7D5FC580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2ECB7-D62C-4E85-9562-CBA657CC51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F95AA-549F-455E-A4CE-85433129B5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88B27-EBC5-4D5D-A31D-8C9EA32805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DAE5C-3C84-484A-A857-60CE3BCECC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1DB79-98CD-4DD2-B833-5EDBE29D71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FBF55-DF87-42EF-A4AF-85D4E22CA9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E3185-C829-47AA-B3E9-B1196048BE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AADD33-E731-47B7-AB6A-8DB1C69608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8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5.jpeg"/><Relationship Id="rId3" Type="http://schemas.openxmlformats.org/officeDocument/2006/relationships/image" Target="../media/image16.jpe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image" Target="../media/image19.jpe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0.jpeg"/><Relationship Id="rId2" Type="http://schemas.openxmlformats.org/officeDocument/2006/relationships/image" Target="../media/image21.png"/><Relationship Id="rId3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8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1052640"/>
          <a:ext cx="6408720" cy="4680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052640"/>
                    <a:ext cx="6408720" cy="468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080" y="0"/>
            <a:ext cx="1828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Plate # 1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"/>
          <p:cNvSpPr/>
          <p:nvPr/>
        </p:nvSpPr>
        <p:spPr>
          <a:xfrm>
            <a:off x="0" y="19270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GRISCELLI" descr=""/>
          <p:cNvPicPr/>
          <p:nvPr/>
        </p:nvPicPr>
        <p:blipFill>
          <a:blip r:embed="rId1"/>
          <a:stretch/>
        </p:blipFill>
        <p:spPr>
          <a:xfrm>
            <a:off x="0" y="1916280"/>
            <a:ext cx="3543480" cy="263808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1800" y="114840"/>
            <a:ext cx="254448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  <a:ea typeface="Times New Roman"/>
              </a:rPr>
              <a:t>Plate #10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LPI%20BIS" descr=""/>
          <p:cNvPicPr/>
          <p:nvPr/>
        </p:nvPicPr>
        <p:blipFill>
          <a:blip r:embed="rId1"/>
          <a:srcRect l="29700" t="25337" r="43273" b="44031"/>
          <a:stretch/>
        </p:blipFill>
        <p:spPr>
          <a:xfrm>
            <a:off x="0" y="2133720"/>
            <a:ext cx="2771640" cy="2361960"/>
          </a:xfrm>
          <a:prstGeom prst="rect">
            <a:avLst/>
          </a:prstGeom>
          <a:ln w="0">
            <a:noFill/>
          </a:ln>
        </p:spPr>
      </p:pic>
      <p:pic>
        <p:nvPicPr>
          <p:cNvPr id="76" name="LPI" descr=""/>
          <p:cNvPicPr/>
          <p:nvPr/>
        </p:nvPicPr>
        <p:blipFill>
          <a:blip r:embed="rId2"/>
          <a:srcRect l="38510" t="18749" r="24367" b="39161"/>
          <a:stretch/>
        </p:blipFill>
        <p:spPr>
          <a:xfrm>
            <a:off x="2700360" y="2133720"/>
            <a:ext cx="2735280" cy="2307960"/>
          </a:xfrm>
          <a:prstGeom prst="rect">
            <a:avLst/>
          </a:prstGeom>
          <a:ln w="0">
            <a:noFill/>
          </a:ln>
        </p:spPr>
      </p:pic>
      <p:pic>
        <p:nvPicPr>
          <p:cNvPr id="77" name="LPI%20TER" descr=""/>
          <p:cNvPicPr/>
          <p:nvPr/>
        </p:nvPicPr>
        <p:blipFill>
          <a:blip r:embed="rId3"/>
          <a:srcRect l="19902" t="27608" r="38510" b="16384"/>
          <a:stretch/>
        </p:blipFill>
        <p:spPr>
          <a:xfrm>
            <a:off x="5435640" y="2133720"/>
            <a:ext cx="2290680" cy="230328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-863640" y="7826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-1044720" y="28526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8000" y="-360"/>
            <a:ext cx="7634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600" spc="-1" strike="noStrike">
                <a:solidFill>
                  <a:srgbClr val="000000"/>
                </a:solidFill>
                <a:latin typeface="Arial"/>
                <a:ea typeface="Times New Roman"/>
              </a:rPr>
              <a:t>Plate # 11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EARSON%20BIS" descr=""/>
          <p:cNvPicPr/>
          <p:nvPr/>
        </p:nvPicPr>
        <p:blipFill>
          <a:blip r:embed="rId1"/>
          <a:srcRect l="12872" t="29549" r="41162" b="12322"/>
          <a:stretch/>
        </p:blipFill>
        <p:spPr>
          <a:xfrm>
            <a:off x="0" y="1844640"/>
            <a:ext cx="2556000" cy="2416320"/>
          </a:xfrm>
          <a:prstGeom prst="rect">
            <a:avLst/>
          </a:prstGeom>
          <a:ln w="0">
            <a:noFill/>
          </a:ln>
        </p:spPr>
      </p:pic>
      <p:pic>
        <p:nvPicPr>
          <p:cNvPr id="82" name="PEARSON" descr=""/>
          <p:cNvPicPr/>
          <p:nvPr/>
        </p:nvPicPr>
        <p:blipFill>
          <a:blip r:embed="rId2"/>
          <a:srcRect l="0" t="20406" r="42486" b="0"/>
          <a:stretch/>
        </p:blipFill>
        <p:spPr>
          <a:xfrm>
            <a:off x="2556000" y="1844640"/>
            <a:ext cx="2307960" cy="2376360"/>
          </a:xfrm>
          <a:prstGeom prst="rect">
            <a:avLst/>
          </a:prstGeom>
          <a:ln w="0">
            <a:noFill/>
          </a:ln>
        </p:spPr>
      </p:pic>
      <p:pic>
        <p:nvPicPr>
          <p:cNvPr id="83" name="PERLS PEARSON" descr=""/>
          <p:cNvPicPr/>
          <p:nvPr/>
        </p:nvPicPr>
        <p:blipFill>
          <a:blip r:embed="rId3"/>
          <a:srcRect l="32315" t="38779" r="17318" b="7412"/>
          <a:stretch/>
        </p:blipFill>
        <p:spPr>
          <a:xfrm>
            <a:off x="4716360" y="1844640"/>
            <a:ext cx="2664000" cy="234792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>
            <a:off x="-1492200" y="7365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0" y="-61560"/>
            <a:ext cx="813600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  <a:ea typeface="Times New Roman"/>
              </a:rPr>
              <a:t>Plate #12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hoto%205a%20Neutropenie%20autoimmune%20photo%204%20a" descr=""/>
          <p:cNvPicPr/>
          <p:nvPr/>
        </p:nvPicPr>
        <p:blipFill>
          <a:blip r:embed="rId1"/>
          <a:srcRect l="23953" t="0" r="19216" b="15670"/>
          <a:stretch/>
        </p:blipFill>
        <p:spPr>
          <a:xfrm>
            <a:off x="250920" y="1125360"/>
            <a:ext cx="2582640" cy="2880000"/>
          </a:xfrm>
          <a:prstGeom prst="rect">
            <a:avLst/>
          </a:prstGeom>
          <a:ln w="0">
            <a:noFill/>
          </a:ln>
        </p:spPr>
      </p:pic>
      <p:pic>
        <p:nvPicPr>
          <p:cNvPr id="87" name="MOELLE NEUTROPENIE AUTOIMMUNE" descr=""/>
          <p:cNvPicPr/>
          <p:nvPr/>
        </p:nvPicPr>
        <p:blipFill>
          <a:blip r:embed="rId2"/>
          <a:stretch/>
        </p:blipFill>
        <p:spPr>
          <a:xfrm>
            <a:off x="2771640" y="1052640"/>
            <a:ext cx="3961080" cy="297000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>
            <a:off x="0" y="6732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160" y="-183600"/>
            <a:ext cx="260532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181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4400" spc="-1" strike="noStrike">
                <a:solidFill>
                  <a:srgbClr val="000000"/>
                </a:solidFill>
                <a:latin typeface="Arial"/>
                <a:ea typeface="Times New Roman"/>
              </a:rPr>
              <a:t>Plate #13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0" y="907920"/>
          <a:ext cx="6300720" cy="4997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907920"/>
                    <a:ext cx="6300720" cy="4997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>
            <a:off x="1440" y="0"/>
            <a:ext cx="238896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Plate # 2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7" dur="indefinite" restart="never" nodeType="tmRoot">
          <p:childTnLst>
            <p:seq>
              <p:cTn id="8" dur="indefinite" nodeType="mainSeq">
                <p:childTnLst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1557360"/>
            <a:ext cx="4896000" cy="3651120"/>
          </a:xfrm>
          <a:prstGeom prst="rect">
            <a:avLst/>
          </a:prstGeom>
          <a:ln w="0">
            <a:noFill/>
          </a:ln>
        </p:spPr>
      </p:pic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Plate # 3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0" y="16905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APLASIE MÉDULLAIRE" descr=""/>
          <p:cNvPicPr/>
          <p:nvPr/>
        </p:nvPicPr>
        <p:blipFill>
          <a:blip r:embed="rId1"/>
          <a:stretch/>
        </p:blipFill>
        <p:spPr>
          <a:xfrm>
            <a:off x="0" y="1197000"/>
            <a:ext cx="5508720" cy="41148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1440" y="-91440"/>
            <a:ext cx="223344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late #4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"/>
          <p:cNvSpPr/>
          <p:nvPr/>
        </p:nvSpPr>
        <p:spPr>
          <a:xfrm>
            <a:off x="0" y="18273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LAM6 EVOLUTION D'UN SHWACHMAN" descr=""/>
          <p:cNvPicPr/>
          <p:nvPr/>
        </p:nvPicPr>
        <p:blipFill>
          <a:blip r:embed="rId1"/>
          <a:stretch/>
        </p:blipFill>
        <p:spPr>
          <a:xfrm>
            <a:off x="0" y="1484280"/>
            <a:ext cx="4859280" cy="362916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2160" y="114840"/>
            <a:ext cx="244980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Plate # 5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MEGACARYOCYTES MONONUCLEES DE PETITE TAILLE" descr=""/>
          <p:cNvPicPr/>
          <p:nvPr/>
        </p:nvPicPr>
        <p:blipFill>
          <a:blip r:embed="rId1"/>
          <a:srcRect l="40298" t="24448" r="0" b="10354"/>
          <a:stretch/>
        </p:blipFill>
        <p:spPr>
          <a:xfrm>
            <a:off x="468360" y="1989000"/>
            <a:ext cx="3456000" cy="2819520"/>
          </a:xfrm>
          <a:prstGeom prst="rect">
            <a:avLst/>
          </a:prstGeom>
          <a:ln w="0">
            <a:noFill/>
          </a:ln>
        </p:spPr>
      </p:pic>
      <p:pic>
        <p:nvPicPr>
          <p:cNvPr id="56" name="MDS%20SHWACHMAN%20DOUBLE%20NOYAU" descr=""/>
          <p:cNvPicPr/>
          <p:nvPr/>
        </p:nvPicPr>
        <p:blipFill>
          <a:blip r:embed="rId2"/>
          <a:srcRect l="37652" t="39522" r="4894" b="0"/>
          <a:stretch/>
        </p:blipFill>
        <p:spPr>
          <a:xfrm>
            <a:off x="3780000" y="1989000"/>
            <a:ext cx="3528720" cy="278136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0" y="11970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800" y="-1080"/>
            <a:ext cx="229464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Plate #6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324000" y="3213000"/>
            <a:ext cx="502920" cy="287280"/>
          </a:xfrm>
          <a:prstGeom prst="line">
            <a:avLst/>
          </a:prstGeom>
          <a:ln w="2232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4284720" y="3933360"/>
            <a:ext cx="574560" cy="430200"/>
          </a:xfrm>
          <a:prstGeom prst="line">
            <a:avLst/>
          </a:prstGeom>
          <a:ln w="2232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0" y="18129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GLYCOGÉNOSE 1B" descr=""/>
          <p:cNvPicPr/>
          <p:nvPr/>
        </p:nvPicPr>
        <p:blipFill>
          <a:blip r:embed="rId1"/>
          <a:stretch/>
        </p:blipFill>
        <p:spPr>
          <a:xfrm>
            <a:off x="0" y="1484280"/>
            <a:ext cx="4859280" cy="36291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2160" y="0"/>
            <a:ext cx="244980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</a:rPr>
              <a:t>Plate # 7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"/>
          <p:cNvSpPr/>
          <p:nvPr/>
        </p:nvSpPr>
        <p:spPr>
          <a:xfrm>
            <a:off x="0" y="18144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0" y="-91440"/>
            <a:ext cx="810108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1810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4400" spc="-1" strike="noStrike">
                <a:solidFill>
                  <a:srgbClr val="000000"/>
                </a:solidFill>
                <a:latin typeface="Arial"/>
                <a:ea typeface="Times New Roman"/>
              </a:rPr>
              <a:t>Plate #8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0" y="1989000"/>
            <a:ext cx="3835440" cy="2867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LYMPHOCYTES CHEDIAK" descr=""/>
          <p:cNvPicPr/>
          <p:nvPr/>
        </p:nvPicPr>
        <p:blipFill>
          <a:blip r:embed="rId1"/>
          <a:srcRect l="25687" t="40224" r="41162" b="24553"/>
          <a:stretch/>
        </p:blipFill>
        <p:spPr>
          <a:xfrm>
            <a:off x="324000" y="1413000"/>
            <a:ext cx="2735280" cy="2368440"/>
          </a:xfrm>
          <a:prstGeom prst="rect">
            <a:avLst/>
          </a:prstGeom>
          <a:ln w="0">
            <a:noFill/>
          </a:ln>
        </p:spPr>
      </p:pic>
      <p:pic>
        <p:nvPicPr>
          <p:cNvPr id="68" name="GRANULATION%20%20GROSSIERE%20EPARSES%20DES%20PN%20CHEDIAK" descr=""/>
          <p:cNvPicPr/>
          <p:nvPr/>
        </p:nvPicPr>
        <p:blipFill>
          <a:blip r:embed="rId2"/>
          <a:srcRect l="25682" t="26833" r="46460" b="37301"/>
          <a:stretch/>
        </p:blipFill>
        <p:spPr>
          <a:xfrm>
            <a:off x="2987640" y="1413000"/>
            <a:ext cx="2376360" cy="230796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0" y="13892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080" y="115200"/>
            <a:ext cx="1909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3600" spc="-1" strike="noStrike">
                <a:solidFill>
                  <a:srgbClr val="000000"/>
                </a:solidFill>
                <a:latin typeface="Arial"/>
                <a:ea typeface="Times New Roman"/>
              </a:rPr>
              <a:t>Plate #9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" descr=""/>
          <p:cNvPicPr/>
          <p:nvPr/>
        </p:nvPicPr>
        <p:blipFill>
          <a:blip r:embed="rId3"/>
          <a:stretch/>
        </p:blipFill>
        <p:spPr>
          <a:xfrm>
            <a:off x="5292720" y="1341360"/>
            <a:ext cx="3851280" cy="236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26T10:29:52Z</dcterms:created>
  <dc:creator>jean</dc:creator>
  <dc:description/>
  <dc:language>en-US</dc:language>
  <cp:lastModifiedBy>jean</cp:lastModifiedBy>
  <dcterms:modified xsi:type="dcterms:W3CDTF">2011-02-13T22:54:44Z</dcterms:modified>
  <cp:revision>9</cp:revision>
  <dc:subject/>
  <dc:title>Diapositive 1</dc:title>
</cp:coreProperties>
</file>